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9" r:id="rId2"/>
  </p:sldIdLst>
  <p:sldSz cx="6840538" cy="9144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0000"/>
    <a:srgbClr val="233E6F"/>
    <a:srgbClr val="2A4B86"/>
    <a:srgbClr val="820000"/>
    <a:srgbClr val="F8AEAE"/>
    <a:srgbClr val="9393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6224" autoAdjust="0"/>
  </p:normalViewPr>
  <p:slideViewPr>
    <p:cSldViewPr snapToGrid="0">
      <p:cViewPr varScale="1">
        <p:scale>
          <a:sx n="70" d="100"/>
          <a:sy n="70" d="100"/>
        </p:scale>
        <p:origin x="321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CC8D25-303F-4077-995E-227DA256540A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143000"/>
            <a:ext cx="2308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345B17-916C-412B-82F5-AEF5ADF5576D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65707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CA" dirty="0"/>
              <a:t>Sup table 1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345B17-916C-412B-82F5-AEF5ADF5576D}" type="slidenum">
              <a:rPr lang="fr-BE" smtClean="0"/>
              <a:t>1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42089164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96484"/>
            <a:ext cx="5814457" cy="318346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802717"/>
            <a:ext cx="5130404" cy="220768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190761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8970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86834"/>
            <a:ext cx="1474991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86834"/>
            <a:ext cx="4339466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65284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74431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79653"/>
            <a:ext cx="5899964" cy="380364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119286"/>
            <a:ext cx="5899964" cy="20002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8825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3865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86836"/>
            <a:ext cx="5899964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41551"/>
            <a:ext cx="2893868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340100"/>
            <a:ext cx="289386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41551"/>
            <a:ext cx="2908120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340100"/>
            <a:ext cx="290812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58807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9115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76084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16569"/>
            <a:ext cx="3463022" cy="6498167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0057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16569"/>
            <a:ext cx="3463022" cy="6498167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03089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86836"/>
            <a:ext cx="589996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34167"/>
            <a:ext cx="589996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475136"/>
            <a:ext cx="2308682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63226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6DC35EC7-FD92-1254-6DFC-273A1E0FD0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4648820"/>
              </p:ext>
            </p:extLst>
          </p:nvPr>
        </p:nvGraphicFramePr>
        <p:xfrm>
          <a:off x="121917" y="120360"/>
          <a:ext cx="6596704" cy="6281511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815638">
                  <a:extLst>
                    <a:ext uri="{9D8B030D-6E8A-4147-A177-3AD203B41FA5}">
                      <a16:colId xmlns:a16="http://schemas.microsoft.com/office/drawing/2014/main" val="2086277466"/>
                    </a:ext>
                  </a:extLst>
                </a:gridCol>
                <a:gridCol w="936350">
                  <a:extLst>
                    <a:ext uri="{9D8B030D-6E8A-4147-A177-3AD203B41FA5}">
                      <a16:colId xmlns:a16="http://schemas.microsoft.com/office/drawing/2014/main" val="3009751787"/>
                    </a:ext>
                  </a:extLst>
                </a:gridCol>
                <a:gridCol w="850232">
                  <a:extLst>
                    <a:ext uri="{9D8B030D-6E8A-4147-A177-3AD203B41FA5}">
                      <a16:colId xmlns:a16="http://schemas.microsoft.com/office/drawing/2014/main" val="2150354374"/>
                    </a:ext>
                  </a:extLst>
                </a:gridCol>
                <a:gridCol w="3012083">
                  <a:extLst>
                    <a:ext uri="{9D8B030D-6E8A-4147-A177-3AD203B41FA5}">
                      <a16:colId xmlns:a16="http://schemas.microsoft.com/office/drawing/2014/main" val="219911373"/>
                    </a:ext>
                  </a:extLst>
                </a:gridCol>
                <a:gridCol w="982401">
                  <a:extLst>
                    <a:ext uri="{9D8B030D-6E8A-4147-A177-3AD203B41FA5}">
                      <a16:colId xmlns:a16="http://schemas.microsoft.com/office/drawing/2014/main" val="4179746898"/>
                    </a:ext>
                  </a:extLst>
                </a:gridCol>
              </a:tblGrid>
              <a:tr h="246471">
                <a:tc gridSpan="5">
                  <a:txBody>
                    <a:bodyPr/>
                    <a:lstStyle/>
                    <a:p>
                      <a:pPr marL="0" marR="0" lvl="0" indent="0" algn="ctr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-9 expression profile of cell cycle genes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0058160"/>
                  </a:ext>
                </a:extLst>
              </a:tr>
              <a:tr h="246471"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gene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seq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d change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1143893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332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33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PC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phase promoting complex subunit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7636510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674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0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xia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elangiectasia mutated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4664820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717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1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xia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elangiectasia and Rad3 related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7414797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7155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65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C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CA2 and CDKN1A interacting 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5846901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941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72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CA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 1, early ons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36352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411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 3, apoptosis-related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steine peptidase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24068716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39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319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B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 B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668911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760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7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D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 D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4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9844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7404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G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 G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2282169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923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T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 T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6900992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249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C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division cycle 20 homolog (S. cerevisia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5099775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149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C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division cycle 34 homolog (S. cerevisia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9032657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000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8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5R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-dependent kinase 5, regulatory subunit 1 (p3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8406742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823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-dependent kinase 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8410082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707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3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1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-dependent kinase inhibitor 1A (p21, Cip 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0446391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389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0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1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-dependent kinase inhibitor 1B (p27, Kip 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6986455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804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9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DD45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wth arrest and DNA-damage-inducible, alph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4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5713533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529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5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S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S1 checkpoint homolog (S. pomb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428691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890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47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TC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netochore associated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1684857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942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22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PNA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ryopherin alpha 2 (RAG cohort 1, importin alpha 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1121888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916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23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D2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D2 mitotic arrest deficient-like 1 (yeast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2464187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774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5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M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ichromosome maintenance complex component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6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5000895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795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23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M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ichromosome maintenance complex component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422795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175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67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M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ichromosome maintenance complex component 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7613837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845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239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M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m2 p53 binding protein homolog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mouse)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9911578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553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5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D9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D9 homolog A (S. pomb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1301495"/>
                  </a:ext>
                </a:extLst>
              </a:tr>
              <a:tr h="203128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698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337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TAD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TA domain containing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46599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74658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5</TotalTime>
  <Words>408</Words>
  <Application>Microsoft Office PowerPoint</Application>
  <PresentationFormat>Personnalisé</PresentationFormat>
  <Paragraphs>14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wraa</dc:creator>
  <cp:lastModifiedBy>Abdelhabib Semlali</cp:lastModifiedBy>
  <cp:revision>567</cp:revision>
  <cp:lastPrinted>2022-12-05T14:26:03Z</cp:lastPrinted>
  <dcterms:created xsi:type="dcterms:W3CDTF">2019-02-19T20:27:18Z</dcterms:created>
  <dcterms:modified xsi:type="dcterms:W3CDTF">2024-04-05T15:20:40Z</dcterms:modified>
</cp:coreProperties>
</file>